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8" d="100"/>
          <a:sy n="68" d="100"/>
        </p:scale>
        <p:origin x="73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54BDF4-7313-421A-A5BA-267725593A6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07312B0-F674-49AB-BEA9-0584BAF80A7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F54D1B-1236-4F82-8920-C5A0EEFF8F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26C48-5CAB-4C50-8F1D-C4E51F10DBF6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5611CE-9079-4D9F-AC9B-DFF2A107F1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531624-CD88-4C17-A21A-C579CCFEB6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FFE35-5449-4316-AAB3-1C674C12B7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45568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574E69-7E3C-45FE-9DDF-39CB777277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F83E4CD-56FA-4343-9F5D-1F30299172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4A6D16-FAB2-4F39-8BCC-4C6322B9D3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26C48-5CAB-4C50-8F1D-C4E51F10DBF6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8AC40F-C967-405A-A933-907DCE96C5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0AEA27-BA2D-40EC-B372-8BFA54E7BE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FFE35-5449-4316-AAB3-1C674C12B7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57028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1A44BC9-DED8-4C45-B8EE-623AAC345D9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FB1E5CA-D5DA-4F53-B8AE-D9F096708C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9E7D23-3070-4052-A009-4E1838175C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26C48-5CAB-4C50-8F1D-C4E51F10DBF6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D5A204-C44A-427E-B1E1-58F3F187CB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69DDFB-7142-4E54-B402-62CF23B763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FFE35-5449-4316-AAB3-1C674C12B7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8120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B885E7-3EAA-4933-8A3C-629DD21E07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5C707DA-C27A-4129-84F5-A0768FAB52C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185DE0-B791-4B0D-ACF3-E72D8553A8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26C48-5CAB-4C50-8F1D-C4E51F10DBF6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0B88AF-D727-46B5-8571-2A71D864F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46A778-ECC7-4F29-B272-14B6231472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FFE35-5449-4316-AAB3-1C674C12B7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08269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5634B0-4017-458A-ABBB-C34242E4D1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3849262-571A-4CF6-A280-C44D12D8E6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B51120-9566-4BB3-8E9D-2EB3DFEB2B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26C48-5CAB-4C50-8F1D-C4E51F10DBF6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0059AE-AC59-4BB4-8AB9-DC7E6BC6FC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0F8EB9-94C6-49B7-87FE-6F1439F3DF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FFE35-5449-4316-AAB3-1C674C12B7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27652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65AA54-9468-4739-A689-F03372A423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E4301E-65A0-458F-A99D-5579B419FFD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FE9D695-EBC6-4954-A44E-6CBE6B7C37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97E0AA3-ECBF-46F5-B43A-3912F88C84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26C48-5CAB-4C50-8F1D-C4E51F10DBF6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E71D4C-4C0D-4912-8BE1-49ED0AC656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9B1705-418B-499F-8968-393331BD1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FFE35-5449-4316-AAB3-1C674C12B7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9146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E4398A-E806-4AA2-8A57-89B8624A74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0DEFE7-AF69-4A47-99FF-B46F26E948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8F726FE-2625-4E8E-8FE6-FCEB430B306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25A9764-100B-4221-A06C-89D91126BA9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0690A0C-1E79-461C-80F9-179B4A695E9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094D2FD-1DD0-47BA-AB26-79F77E1B41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26C48-5CAB-4C50-8F1D-C4E51F10DBF6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506E21F-8B3D-4170-81D7-A46E17A56B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FDAA2E2-1064-4C1A-9B31-43E51CCA50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FFE35-5449-4316-AAB3-1C674C12B7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70372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DD4917-EC4C-4906-8595-6482FF3FA8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1540810-4BDE-4E02-8D16-27616D8836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26C48-5CAB-4C50-8F1D-C4E51F10DBF6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93C782C-E67A-4B4D-8B00-76270B2348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70A421A-870A-426B-8BD7-D895E7BF32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FFE35-5449-4316-AAB3-1C674C12B7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47087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3A44C4D-8F70-425C-B0A6-392590439B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26C48-5CAB-4C50-8F1D-C4E51F10DBF6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4B0F6EF-686F-47A0-A88C-D2C01F912C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914CA30-FA7C-43AB-AD93-5C4F5806D7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FFE35-5449-4316-AAB3-1C674C12B7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9426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ABB83C-7209-432A-9AF2-56CF074D24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713785-E808-440C-923B-439965556A4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2DD1640-D555-4112-BE1E-F0C4DC92D4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530B1D-F67F-4C87-9BD8-12A9A48261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26C48-5CAB-4C50-8F1D-C4E51F10DBF6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B7A8F9D-BD22-4819-BF10-AD48FE679E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FF6B86-615F-43F6-9256-F2CBD2318A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FFE35-5449-4316-AAB3-1C674C12B7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28718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9E3257-4282-4096-8A98-4AEA990BC2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D3330D6-173B-496C-834C-76DB407E444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974CC64-CF40-4285-A3D5-2C9D6C02C8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D3E908-3160-427D-B889-01178211E6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26C48-5CAB-4C50-8F1D-C4E51F10DBF6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EC56C8D-724F-4915-917F-41D1C21473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E31224-6FC4-471F-9EAC-37A707AF2A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FFE35-5449-4316-AAB3-1C674C12B7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27466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DD9389E-EC17-48F0-8C2C-D2C30C8472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F8E15E-3CAE-4328-9001-D5CA0A1C6E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2AECA3-350E-4347-8190-7FB01FE954B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B26C48-5CAB-4C50-8F1D-C4E51F10DBF6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7A7C78-4B97-4EEE-AB22-FFFD5EECAC0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DC7634-C6DB-44C4-A4BD-1E9417FEC74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0FFE35-5449-4316-AAB3-1C674C12B7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41343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1FBD9BAF-0E1D-440B-AF54-CAD376A1F59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96759966"/>
              </p:ext>
            </p:extLst>
          </p:nvPr>
        </p:nvGraphicFramePr>
        <p:xfrm>
          <a:off x="1561514" y="998806"/>
          <a:ext cx="7948246" cy="4783021"/>
        </p:xfrm>
        <a:graphic>
          <a:graphicData uri="http://schemas.openxmlformats.org/drawingml/2006/table">
            <a:tbl>
              <a:tblPr firstRow="1" firstCol="1" bandRow="1"/>
              <a:tblGrid>
                <a:gridCol w="3630043">
                  <a:extLst>
                    <a:ext uri="{9D8B030D-6E8A-4147-A177-3AD203B41FA5}">
                      <a16:colId xmlns:a16="http://schemas.microsoft.com/office/drawing/2014/main" val="486283854"/>
                    </a:ext>
                  </a:extLst>
                </a:gridCol>
                <a:gridCol w="4318203">
                  <a:extLst>
                    <a:ext uri="{9D8B030D-6E8A-4147-A177-3AD203B41FA5}">
                      <a16:colId xmlns:a16="http://schemas.microsoft.com/office/drawing/2014/main" val="835377444"/>
                    </a:ext>
                  </a:extLst>
                </a:gridCol>
              </a:tblGrid>
              <a:tr h="316357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600" b="1" kern="120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ame (length, bp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600"/>
                        </a:spcAft>
                      </a:pPr>
                      <a:r>
                        <a:rPr lang="en-GB" sz="1600" b="1" kern="120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equence (5’ to 3’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41111704"/>
                  </a:ext>
                </a:extLst>
              </a:tr>
              <a:tr h="354023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1600" b="1" i="1" kern="120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CTB</a:t>
                      </a:r>
                      <a:r>
                        <a:rPr lang="en-GB" sz="1600" b="1" kern="120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(336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16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 (CCCAAGGCCAACCGTGAGAAGATGA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69582481"/>
                  </a:ext>
                </a:extLst>
              </a:tr>
              <a:tr h="316357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600" b="1" kern="120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6000"/>
                        </a:lnSpc>
                        <a:spcAft>
                          <a:spcPts val="600"/>
                        </a:spcAft>
                      </a:pPr>
                      <a:r>
                        <a:rPr lang="en-GB" sz="16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 (CGAAGTCCAGGGCCACGTAGCAGA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34189973"/>
                  </a:ext>
                </a:extLst>
              </a:tr>
              <a:tr h="316357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600" b="1" i="1" kern="120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OL1A1</a:t>
                      </a:r>
                      <a:r>
                        <a:rPr lang="en-GB" sz="1600" b="1" kern="120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(93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6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 (CCTGCGTACAGAACGGCCT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60169019"/>
                  </a:ext>
                </a:extLst>
              </a:tr>
              <a:tr h="316357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600" b="1" kern="120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600"/>
                        </a:spcAft>
                      </a:pPr>
                      <a:r>
                        <a:rPr lang="en-GB" sz="16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 (ACAGCACGTTGCCGTTGTC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46161487"/>
                  </a:ext>
                </a:extLst>
              </a:tr>
              <a:tr h="316357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600" b="1" i="1" kern="120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OCN</a:t>
                      </a:r>
                      <a:r>
                        <a:rPr lang="en-GB" sz="1600" b="1" kern="120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(145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6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 (CAGCGAGGTGGTGAAGAG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4407415"/>
                  </a:ext>
                </a:extLst>
              </a:tr>
              <a:tr h="316357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600" b="1" kern="120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600"/>
                        </a:spcAft>
                      </a:pPr>
                      <a:r>
                        <a:rPr lang="en-GB" sz="16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 (CTGGAAGCCGATGTGGTC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48531551"/>
                  </a:ext>
                </a:extLst>
              </a:tr>
              <a:tr h="316357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600" b="1" i="1" kern="120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OL2A1</a:t>
                      </a:r>
                      <a:r>
                        <a:rPr lang="en-GB" sz="1600" b="1" kern="120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(225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6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 (TGGGACTGTCCTCTGCGAC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62262367"/>
                  </a:ext>
                </a:extLst>
              </a:tr>
              <a:tr h="316357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600" b="1" kern="120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600"/>
                        </a:spcAft>
                      </a:pPr>
                      <a:r>
                        <a:rPr lang="en-GB" sz="16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 (CTGGGTCCTTGTTCACCTGC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26684602"/>
                  </a:ext>
                </a:extLst>
              </a:tr>
              <a:tr h="316357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600" b="1" i="1" kern="120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CAN</a:t>
                      </a:r>
                      <a:r>
                        <a:rPr lang="en-GB" sz="1600" b="1" kern="120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(108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6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 (TGGGAGTGAGGACCGTCTAC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98736692"/>
                  </a:ext>
                </a:extLst>
              </a:tr>
              <a:tr h="316357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600" b="1" kern="120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600"/>
                        </a:spcAft>
                      </a:pPr>
                      <a:r>
                        <a:rPr lang="en-GB" sz="16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 (CTGGGATGTCCACAAAGTC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7626158"/>
                  </a:ext>
                </a:extLst>
              </a:tr>
              <a:tr h="316357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600" b="1" i="1" kern="120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OX9</a:t>
                      </a:r>
                      <a:r>
                        <a:rPr lang="en-GB" sz="1600" b="1" kern="120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(115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6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 (GCAAGCTCTGGAGGCTGCT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11984616"/>
                  </a:ext>
                </a:extLst>
              </a:tr>
              <a:tr h="316357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600" b="1" kern="120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600"/>
                        </a:spcAft>
                      </a:pPr>
                      <a:r>
                        <a:rPr lang="en-GB" sz="16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 (CTCCGCGGCTGGTACTTGT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51025788"/>
                  </a:ext>
                </a:extLst>
              </a:tr>
              <a:tr h="316357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600" b="1" i="1" kern="120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PARG</a:t>
                      </a:r>
                      <a:r>
                        <a:rPr lang="en-GB" sz="1600" b="1" kern="120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(94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6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 (GCCCTGGCAAAGCATTTGTA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4639037"/>
                  </a:ext>
                </a:extLst>
              </a:tr>
              <a:tr h="316357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600" b="1" kern="120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600"/>
                        </a:spcAft>
                      </a:pPr>
                      <a:r>
                        <a:rPr lang="en-GB" sz="160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 (TGTCTGTCGTCTTTCCCGTC)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1211946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554048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</TotalTime>
  <Words>98</Words>
  <Application>Microsoft Office PowerPoint</Application>
  <PresentationFormat>Widescreen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nczler J.M.</dc:creator>
  <cp:lastModifiedBy>Kanczler J.M.</cp:lastModifiedBy>
  <cp:revision>2</cp:revision>
  <dcterms:created xsi:type="dcterms:W3CDTF">2020-03-23T12:44:37Z</dcterms:created>
  <dcterms:modified xsi:type="dcterms:W3CDTF">2020-03-23T14:35:27Z</dcterms:modified>
</cp:coreProperties>
</file>